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  <p:sldMasterId id="2147483684" r:id="rId3"/>
    <p:sldMasterId id="2147483708" r:id="rId4"/>
  </p:sldMasterIdLst>
  <p:notesMasterIdLst>
    <p:notesMasterId r:id="rId7"/>
  </p:notesMasterIdLst>
  <p:sldIdLst>
    <p:sldId id="359" r:id="rId5"/>
    <p:sldId id="351" r:id="rId6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173" autoAdjust="0"/>
    <p:restoredTop sz="97049" autoAdjust="0"/>
  </p:normalViewPr>
  <p:slideViewPr>
    <p:cSldViewPr snapToGrid="0">
      <p:cViewPr varScale="1">
        <p:scale>
          <a:sx n="70" d="100"/>
          <a:sy n="70" d="100"/>
        </p:scale>
        <p:origin x="1938" y="7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 Sun" userId="125ba65f-73db-4e1b-8896-523d9a3dbc8a" providerId="ADAL" clId="{AA4E19D0-4B38-47D0-837A-A82761BC145C}"/>
    <pc:docChg chg="delSld delMainMaster">
      <pc:chgData name="Yu Sun" userId="125ba65f-73db-4e1b-8896-523d9a3dbc8a" providerId="ADAL" clId="{AA4E19D0-4B38-47D0-837A-A82761BC145C}" dt="2020-11-16T02:24:20.653" v="17" actId="47"/>
      <pc:docMkLst>
        <pc:docMk/>
      </pc:docMkLst>
      <pc:sldChg chg="del">
        <pc:chgData name="Yu Sun" userId="125ba65f-73db-4e1b-8896-523d9a3dbc8a" providerId="ADAL" clId="{AA4E19D0-4B38-47D0-837A-A82761BC145C}" dt="2020-11-16T02:24:14.094" v="0" actId="47"/>
        <pc:sldMkLst>
          <pc:docMk/>
          <pc:sldMk cId="1938962723" sldId="261"/>
        </pc:sldMkLst>
      </pc:sldChg>
      <pc:sldChg chg="del">
        <pc:chgData name="Yu Sun" userId="125ba65f-73db-4e1b-8896-523d9a3dbc8a" providerId="ADAL" clId="{AA4E19D0-4B38-47D0-837A-A82761BC145C}" dt="2020-11-16T02:24:17.964" v="10" actId="47"/>
        <pc:sldMkLst>
          <pc:docMk/>
          <pc:sldMk cId="3666691405" sldId="269"/>
        </pc:sldMkLst>
      </pc:sldChg>
      <pc:sldChg chg="del">
        <pc:chgData name="Yu Sun" userId="125ba65f-73db-4e1b-8896-523d9a3dbc8a" providerId="ADAL" clId="{AA4E19D0-4B38-47D0-837A-A82761BC145C}" dt="2020-11-16T02:24:15.075" v="2" actId="47"/>
        <pc:sldMkLst>
          <pc:docMk/>
          <pc:sldMk cId="716523990" sldId="273"/>
        </pc:sldMkLst>
      </pc:sldChg>
      <pc:sldChg chg="del">
        <pc:chgData name="Yu Sun" userId="125ba65f-73db-4e1b-8896-523d9a3dbc8a" providerId="ADAL" clId="{AA4E19D0-4B38-47D0-837A-A82761BC145C}" dt="2020-11-16T02:24:18.323" v="11" actId="47"/>
        <pc:sldMkLst>
          <pc:docMk/>
          <pc:sldMk cId="3557521796" sldId="275"/>
        </pc:sldMkLst>
      </pc:sldChg>
      <pc:sldChg chg="del">
        <pc:chgData name="Yu Sun" userId="125ba65f-73db-4e1b-8896-523d9a3dbc8a" providerId="ADAL" clId="{AA4E19D0-4B38-47D0-837A-A82761BC145C}" dt="2020-11-16T02:24:18.609" v="12" actId="47"/>
        <pc:sldMkLst>
          <pc:docMk/>
          <pc:sldMk cId="3111287195" sldId="279"/>
        </pc:sldMkLst>
      </pc:sldChg>
      <pc:sldChg chg="del">
        <pc:chgData name="Yu Sun" userId="125ba65f-73db-4e1b-8896-523d9a3dbc8a" providerId="ADAL" clId="{AA4E19D0-4B38-47D0-837A-A82761BC145C}" dt="2020-11-16T02:24:16.176" v="5" actId="47"/>
        <pc:sldMkLst>
          <pc:docMk/>
          <pc:sldMk cId="1733467602" sldId="281"/>
        </pc:sldMkLst>
      </pc:sldChg>
      <pc:sldChg chg="del">
        <pc:chgData name="Yu Sun" userId="125ba65f-73db-4e1b-8896-523d9a3dbc8a" providerId="ADAL" clId="{AA4E19D0-4B38-47D0-837A-A82761BC145C}" dt="2020-11-16T02:24:16.537" v="6" actId="47"/>
        <pc:sldMkLst>
          <pc:docMk/>
          <pc:sldMk cId="2332993914" sldId="285"/>
        </pc:sldMkLst>
      </pc:sldChg>
      <pc:sldChg chg="del">
        <pc:chgData name="Yu Sun" userId="125ba65f-73db-4e1b-8896-523d9a3dbc8a" providerId="ADAL" clId="{AA4E19D0-4B38-47D0-837A-A82761BC145C}" dt="2020-11-16T02:24:16.930" v="7" actId="47"/>
        <pc:sldMkLst>
          <pc:docMk/>
          <pc:sldMk cId="1718241453" sldId="289"/>
        </pc:sldMkLst>
      </pc:sldChg>
      <pc:sldChg chg="del">
        <pc:chgData name="Yu Sun" userId="125ba65f-73db-4e1b-8896-523d9a3dbc8a" providerId="ADAL" clId="{AA4E19D0-4B38-47D0-837A-A82761BC145C}" dt="2020-11-16T02:24:17.272" v="8" actId="47"/>
        <pc:sldMkLst>
          <pc:docMk/>
          <pc:sldMk cId="2112230028" sldId="291"/>
        </pc:sldMkLst>
      </pc:sldChg>
      <pc:sldChg chg="del">
        <pc:chgData name="Yu Sun" userId="125ba65f-73db-4e1b-8896-523d9a3dbc8a" providerId="ADAL" clId="{AA4E19D0-4B38-47D0-837A-A82761BC145C}" dt="2020-11-16T02:24:17.660" v="9" actId="47"/>
        <pc:sldMkLst>
          <pc:docMk/>
          <pc:sldMk cId="2406648255" sldId="294"/>
        </pc:sldMkLst>
      </pc:sldChg>
      <pc:sldChg chg="del">
        <pc:chgData name="Yu Sun" userId="125ba65f-73db-4e1b-8896-523d9a3dbc8a" providerId="ADAL" clId="{AA4E19D0-4B38-47D0-837A-A82761BC145C}" dt="2020-11-16T02:24:14.611" v="1" actId="47"/>
        <pc:sldMkLst>
          <pc:docMk/>
          <pc:sldMk cId="1450320870" sldId="298"/>
        </pc:sldMkLst>
      </pc:sldChg>
      <pc:sldChg chg="del">
        <pc:chgData name="Yu Sun" userId="125ba65f-73db-4e1b-8896-523d9a3dbc8a" providerId="ADAL" clId="{AA4E19D0-4B38-47D0-837A-A82761BC145C}" dt="2020-11-16T02:24:19.132" v="14" actId="47"/>
        <pc:sldMkLst>
          <pc:docMk/>
          <pc:sldMk cId="1789286722" sldId="348"/>
        </pc:sldMkLst>
      </pc:sldChg>
      <pc:sldChg chg="del">
        <pc:chgData name="Yu Sun" userId="125ba65f-73db-4e1b-8896-523d9a3dbc8a" providerId="ADAL" clId="{AA4E19D0-4B38-47D0-837A-A82761BC145C}" dt="2020-11-16T02:24:15.787" v="4" actId="47"/>
        <pc:sldMkLst>
          <pc:docMk/>
          <pc:sldMk cId="3140053047" sldId="358"/>
        </pc:sldMkLst>
      </pc:sldChg>
      <pc:sldChg chg="del">
        <pc:chgData name="Yu Sun" userId="125ba65f-73db-4e1b-8896-523d9a3dbc8a" providerId="ADAL" clId="{AA4E19D0-4B38-47D0-837A-A82761BC145C}" dt="2020-11-16T02:24:19.321" v="15" actId="47"/>
        <pc:sldMkLst>
          <pc:docMk/>
          <pc:sldMk cId="1887563136" sldId="360"/>
        </pc:sldMkLst>
      </pc:sldChg>
      <pc:sldChg chg="del">
        <pc:chgData name="Yu Sun" userId="125ba65f-73db-4e1b-8896-523d9a3dbc8a" providerId="ADAL" clId="{AA4E19D0-4B38-47D0-837A-A82761BC145C}" dt="2020-11-16T02:24:19.844" v="16" actId="47"/>
        <pc:sldMkLst>
          <pc:docMk/>
          <pc:sldMk cId="142983764" sldId="361"/>
        </pc:sldMkLst>
      </pc:sldChg>
      <pc:sldChg chg="del">
        <pc:chgData name="Yu Sun" userId="125ba65f-73db-4e1b-8896-523d9a3dbc8a" providerId="ADAL" clId="{AA4E19D0-4B38-47D0-837A-A82761BC145C}" dt="2020-11-16T02:24:20.653" v="17" actId="47"/>
        <pc:sldMkLst>
          <pc:docMk/>
          <pc:sldMk cId="849487430" sldId="362"/>
        </pc:sldMkLst>
      </pc:sldChg>
      <pc:sldChg chg="del">
        <pc:chgData name="Yu Sun" userId="125ba65f-73db-4e1b-8896-523d9a3dbc8a" providerId="ADAL" clId="{AA4E19D0-4B38-47D0-837A-A82761BC145C}" dt="2020-11-16T02:24:18.947" v="13" actId="47"/>
        <pc:sldMkLst>
          <pc:docMk/>
          <pc:sldMk cId="2648001005" sldId="363"/>
        </pc:sldMkLst>
      </pc:sldChg>
      <pc:sldChg chg="del">
        <pc:chgData name="Yu Sun" userId="125ba65f-73db-4e1b-8896-523d9a3dbc8a" providerId="ADAL" clId="{AA4E19D0-4B38-47D0-837A-A82761BC145C}" dt="2020-11-16T02:24:15.459" v="3" actId="47"/>
        <pc:sldMkLst>
          <pc:docMk/>
          <pc:sldMk cId="1424164148" sldId="366"/>
        </pc:sldMkLst>
      </pc:sldChg>
      <pc:sldMasterChg chg="del delSldLayout">
        <pc:chgData name="Yu Sun" userId="125ba65f-73db-4e1b-8896-523d9a3dbc8a" providerId="ADAL" clId="{AA4E19D0-4B38-47D0-837A-A82761BC145C}" dt="2020-11-16T02:24:20.653" v="17" actId="47"/>
        <pc:sldMasterMkLst>
          <pc:docMk/>
          <pc:sldMasterMk cId="3701908404" sldId="2147483744"/>
        </pc:sldMasterMkLst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1380823780" sldId="2147483745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3361723451" sldId="2147483746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1726105198" sldId="2147483747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2145660257" sldId="2147483748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2733606871" sldId="2147483749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727139283" sldId="2147483750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2749157277" sldId="2147483751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4038616484" sldId="2147483752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1662312520" sldId="2147483753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2742181157" sldId="2147483754"/>
          </pc:sldLayoutMkLst>
        </pc:sldLayoutChg>
        <pc:sldLayoutChg chg="del">
          <pc:chgData name="Yu Sun" userId="125ba65f-73db-4e1b-8896-523d9a3dbc8a" providerId="ADAL" clId="{AA4E19D0-4B38-47D0-837A-A82761BC145C}" dt="2020-11-16T02:24:20.653" v="17" actId="47"/>
          <pc:sldLayoutMkLst>
            <pc:docMk/>
            <pc:sldMasterMk cId="3701908404" sldId="2147483744"/>
            <pc:sldLayoutMk cId="1422736420" sldId="2147483755"/>
          </pc:sldLayoutMkLst>
        </pc:sldLayoutChg>
      </pc:sldMasterChg>
      <pc:sldMasterChg chg="del delSldLayout">
        <pc:chgData name="Yu Sun" userId="125ba65f-73db-4e1b-8896-523d9a3dbc8a" providerId="ADAL" clId="{AA4E19D0-4B38-47D0-837A-A82761BC145C}" dt="2020-11-16T02:24:17.272" v="8" actId="47"/>
        <pc:sldMasterMkLst>
          <pc:docMk/>
          <pc:sldMasterMk cId="699207627" sldId="2147483756"/>
        </pc:sldMasterMkLst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3418195281" sldId="2147483757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1430313116" sldId="2147483758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1118930075" sldId="2147483759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2264817444" sldId="2147483760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3012987867" sldId="2147483761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2596201707" sldId="2147483762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823274194" sldId="2147483763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4273711427" sldId="2147483764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2638786576" sldId="2147483765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117629995" sldId="2147483766"/>
          </pc:sldLayoutMkLst>
        </pc:sldLayoutChg>
        <pc:sldLayoutChg chg="del">
          <pc:chgData name="Yu Sun" userId="125ba65f-73db-4e1b-8896-523d9a3dbc8a" providerId="ADAL" clId="{AA4E19D0-4B38-47D0-837A-A82761BC145C}" dt="2020-11-16T02:24:17.272" v="8" actId="47"/>
          <pc:sldLayoutMkLst>
            <pc:docMk/>
            <pc:sldMasterMk cId="699207627" sldId="2147483756"/>
            <pc:sldLayoutMk cId="434486887" sldId="2147483767"/>
          </pc:sldLayoutMkLst>
        </pc:sldLayoutChg>
      </pc:sldMaster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F1245F-1AF3-4152-809A-421E5E6AC940}" type="datetimeFigureOut">
              <a:rPr lang="en-US" smtClean="0"/>
              <a:t>11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A2C34F-BE32-4EB5-AFA7-EA5C13786A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5632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A2C34F-BE32-4EB5-AFA7-EA5C13786A7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2641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9311"/>
            <a:ext cx="5829300" cy="3501814"/>
          </a:xfrm>
        </p:spPr>
        <p:txBody>
          <a:bodyPr anchor="b">
            <a:normAutofit/>
          </a:bodyPr>
          <a:lstStyle>
            <a:lvl1pPr algn="ctr">
              <a:defRPr sz="32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>
            <a:normAutofit/>
          </a:bodyPr>
          <a:lstStyle>
            <a:lvl1pPr marL="0" indent="0" algn="ctr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 algn="ctr">
              <a:buNone/>
              <a:defRPr sz="1510"/>
            </a:lvl2pPr>
            <a:lvl3pPr marL="493253" indent="0" algn="ctr">
              <a:buNone/>
              <a:defRPr sz="1295"/>
            </a:lvl3pPr>
            <a:lvl4pPr marL="739878" indent="0" algn="ctr">
              <a:buNone/>
              <a:defRPr sz="1079"/>
            </a:lvl4pPr>
            <a:lvl5pPr marL="986505" indent="0" algn="ctr">
              <a:buNone/>
              <a:defRPr sz="1079"/>
            </a:lvl5pPr>
            <a:lvl6pPr marL="1233131" indent="0" algn="ctr">
              <a:buNone/>
              <a:defRPr sz="1079"/>
            </a:lvl6pPr>
            <a:lvl7pPr marL="1479757" indent="0" algn="ctr">
              <a:buNone/>
              <a:defRPr sz="1079"/>
            </a:lvl7pPr>
            <a:lvl8pPr marL="1726383" indent="0" algn="ctr">
              <a:buNone/>
              <a:defRPr sz="1079"/>
            </a:lvl8pPr>
            <a:lvl9pPr marL="1973009" indent="0" algn="ctr">
              <a:buNone/>
              <a:defRPr sz="1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45247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772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3" y="528531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2" y="528535"/>
            <a:ext cx="4930616" cy="85240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07828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9311"/>
            <a:ext cx="5829300" cy="3501814"/>
          </a:xfrm>
        </p:spPr>
        <p:txBody>
          <a:bodyPr anchor="b">
            <a:normAutofit/>
          </a:bodyPr>
          <a:lstStyle>
            <a:lvl1pPr algn="ctr">
              <a:defRPr sz="32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>
            <a:normAutofit/>
          </a:bodyPr>
          <a:lstStyle>
            <a:lvl1pPr marL="0" indent="0" algn="ctr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 algn="ctr">
              <a:buNone/>
              <a:defRPr sz="1510"/>
            </a:lvl2pPr>
            <a:lvl3pPr marL="493253" indent="0" algn="ctr">
              <a:buNone/>
              <a:defRPr sz="1295"/>
            </a:lvl3pPr>
            <a:lvl4pPr marL="739878" indent="0" algn="ctr">
              <a:buNone/>
              <a:defRPr sz="1079"/>
            </a:lvl4pPr>
            <a:lvl5pPr marL="986505" indent="0" algn="ctr">
              <a:buNone/>
              <a:defRPr sz="1079"/>
            </a:lvl5pPr>
            <a:lvl6pPr marL="1233131" indent="0" algn="ctr">
              <a:buNone/>
              <a:defRPr sz="1079"/>
            </a:lvl6pPr>
            <a:lvl7pPr marL="1479757" indent="0" algn="ctr">
              <a:buNone/>
              <a:defRPr sz="1079"/>
            </a:lvl7pPr>
            <a:lvl8pPr marL="1726383" indent="0" algn="ctr">
              <a:buNone/>
              <a:defRPr sz="1079"/>
            </a:lvl8pPr>
            <a:lvl9pPr marL="1973009" indent="0" algn="ctr">
              <a:buNone/>
              <a:defRPr sz="1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749748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292599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7" y="2511554"/>
            <a:ext cx="6703695" cy="4181772"/>
          </a:xfrm>
        </p:spPr>
        <p:txBody>
          <a:bodyPr anchor="b">
            <a:normAutofit/>
          </a:bodyPr>
          <a:lstStyle>
            <a:lvl1pPr>
              <a:defRPr sz="3237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7" y="6677197"/>
            <a:ext cx="6703695" cy="2200274"/>
          </a:xfrm>
        </p:spPr>
        <p:txBody>
          <a:bodyPr anchor="t">
            <a:normAutofit/>
          </a:bodyPr>
          <a:lstStyle>
            <a:lvl1pPr marL="0" indent="0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>
              <a:buNone/>
              <a:defRPr sz="971">
                <a:solidFill>
                  <a:schemeClr val="tx1">
                    <a:tint val="75000"/>
                  </a:schemeClr>
                </a:solidFill>
              </a:defRPr>
            </a:lvl2pPr>
            <a:lvl3pPr marL="493253" indent="0">
              <a:buNone/>
              <a:defRPr sz="863">
                <a:solidFill>
                  <a:schemeClr val="tx1">
                    <a:tint val="75000"/>
                  </a:schemeClr>
                </a:solidFill>
              </a:defRPr>
            </a:lvl3pPr>
            <a:lvl4pPr marL="73987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98650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233131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4797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726383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97300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002785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876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744863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69" y="2466715"/>
            <a:ext cx="3287078" cy="1211026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8769" y="3677742"/>
            <a:ext cx="3287078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81" y="2466714"/>
            <a:ext cx="3303271" cy="1211024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81" y="3677742"/>
            <a:ext cx="3303271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321102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19927378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3261789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4"/>
            <a:ext cx="2506599" cy="2346956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>
              <a:defRPr sz="1726"/>
            </a:lvl1pPr>
            <a:lvl2pPr>
              <a:defRPr sz="1510"/>
            </a:lvl2pPr>
            <a:lvl3pPr>
              <a:defRPr sz="1295"/>
            </a:lvl3pPr>
            <a:lvl4pPr>
              <a:defRPr sz="1079"/>
            </a:lvl4pPr>
            <a:lvl5pPr>
              <a:defRPr sz="1079"/>
            </a:lvl5pPr>
            <a:lvl6pPr>
              <a:defRPr sz="1079"/>
            </a:lvl6pPr>
            <a:lvl7pPr>
              <a:defRPr sz="1079"/>
            </a:lvl7pPr>
            <a:lvl8pPr>
              <a:defRPr sz="1079"/>
            </a:lvl8pPr>
            <a:lvl9pPr>
              <a:defRPr sz="10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2"/>
            <a:ext cx="2506599" cy="5588002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5079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49824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0"/>
            <a:ext cx="2506599" cy="2346960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 marL="0" indent="0">
              <a:buNone/>
              <a:defRPr sz="1726"/>
            </a:lvl1pPr>
            <a:lvl2pPr marL="246627" indent="0">
              <a:buNone/>
              <a:defRPr sz="1510"/>
            </a:lvl2pPr>
            <a:lvl3pPr marL="493253" indent="0">
              <a:buNone/>
              <a:defRPr sz="1295"/>
            </a:lvl3pPr>
            <a:lvl4pPr marL="739878" indent="0">
              <a:buNone/>
              <a:defRPr sz="1079"/>
            </a:lvl4pPr>
            <a:lvl5pPr marL="986505" indent="0">
              <a:buNone/>
              <a:defRPr sz="1079"/>
            </a:lvl5pPr>
            <a:lvl6pPr marL="1233131" indent="0">
              <a:buNone/>
              <a:defRPr sz="1079"/>
            </a:lvl6pPr>
            <a:lvl7pPr marL="1479757" indent="0">
              <a:buNone/>
              <a:defRPr sz="1079"/>
            </a:lvl7pPr>
            <a:lvl8pPr marL="1726383" indent="0">
              <a:buNone/>
              <a:defRPr sz="1079"/>
            </a:lvl8pPr>
            <a:lvl9pPr marL="1973009" indent="0">
              <a:buNone/>
              <a:defRPr sz="107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0"/>
            <a:ext cx="2506599" cy="5588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472654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5094741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3" y="528531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2" y="528535"/>
            <a:ext cx="4930616" cy="85240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621167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9311"/>
            <a:ext cx="5829300" cy="3501814"/>
          </a:xfrm>
        </p:spPr>
        <p:txBody>
          <a:bodyPr anchor="b">
            <a:normAutofit/>
          </a:bodyPr>
          <a:lstStyle>
            <a:lvl1pPr algn="ctr">
              <a:defRPr sz="32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>
            <a:normAutofit/>
          </a:bodyPr>
          <a:lstStyle>
            <a:lvl1pPr marL="0" indent="0" algn="ctr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 algn="ctr">
              <a:buNone/>
              <a:defRPr sz="1510"/>
            </a:lvl2pPr>
            <a:lvl3pPr marL="493253" indent="0" algn="ctr">
              <a:buNone/>
              <a:defRPr sz="1295"/>
            </a:lvl3pPr>
            <a:lvl4pPr marL="739878" indent="0" algn="ctr">
              <a:buNone/>
              <a:defRPr sz="1079"/>
            </a:lvl4pPr>
            <a:lvl5pPr marL="986505" indent="0" algn="ctr">
              <a:buNone/>
              <a:defRPr sz="1079"/>
            </a:lvl5pPr>
            <a:lvl6pPr marL="1233131" indent="0" algn="ctr">
              <a:buNone/>
              <a:defRPr sz="1079"/>
            </a:lvl6pPr>
            <a:lvl7pPr marL="1479757" indent="0" algn="ctr">
              <a:buNone/>
              <a:defRPr sz="1079"/>
            </a:lvl7pPr>
            <a:lvl8pPr marL="1726383" indent="0" algn="ctr">
              <a:buNone/>
              <a:defRPr sz="1079"/>
            </a:lvl8pPr>
            <a:lvl9pPr marL="1973009" indent="0" algn="ctr">
              <a:buNone/>
              <a:defRPr sz="1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8223074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6969873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7" y="2511554"/>
            <a:ext cx="6703695" cy="4181772"/>
          </a:xfrm>
        </p:spPr>
        <p:txBody>
          <a:bodyPr anchor="b">
            <a:normAutofit/>
          </a:bodyPr>
          <a:lstStyle>
            <a:lvl1pPr>
              <a:defRPr sz="3237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7" y="6677197"/>
            <a:ext cx="6703695" cy="2200274"/>
          </a:xfrm>
        </p:spPr>
        <p:txBody>
          <a:bodyPr anchor="t">
            <a:normAutofit/>
          </a:bodyPr>
          <a:lstStyle>
            <a:lvl1pPr marL="0" indent="0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>
              <a:buNone/>
              <a:defRPr sz="971">
                <a:solidFill>
                  <a:schemeClr val="tx1">
                    <a:tint val="75000"/>
                  </a:schemeClr>
                </a:solidFill>
              </a:defRPr>
            </a:lvl2pPr>
            <a:lvl3pPr marL="493253" indent="0">
              <a:buNone/>
              <a:defRPr sz="863">
                <a:solidFill>
                  <a:schemeClr val="tx1">
                    <a:tint val="75000"/>
                  </a:schemeClr>
                </a:solidFill>
              </a:defRPr>
            </a:lvl3pPr>
            <a:lvl4pPr marL="73987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98650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233131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4797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726383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97300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78693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876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3763751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69" y="2466715"/>
            <a:ext cx="3287078" cy="1211026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8769" y="3677742"/>
            <a:ext cx="3287078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81" y="2466714"/>
            <a:ext cx="3303271" cy="1211024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81" y="3677742"/>
            <a:ext cx="3303271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317131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051187432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8018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7" y="2511554"/>
            <a:ext cx="6703695" cy="4181772"/>
          </a:xfrm>
        </p:spPr>
        <p:txBody>
          <a:bodyPr anchor="b">
            <a:normAutofit/>
          </a:bodyPr>
          <a:lstStyle>
            <a:lvl1pPr>
              <a:defRPr sz="3237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7" y="6677197"/>
            <a:ext cx="6703695" cy="2200274"/>
          </a:xfrm>
        </p:spPr>
        <p:txBody>
          <a:bodyPr anchor="t">
            <a:normAutofit/>
          </a:bodyPr>
          <a:lstStyle>
            <a:lvl1pPr marL="0" indent="0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>
              <a:buNone/>
              <a:defRPr sz="971">
                <a:solidFill>
                  <a:schemeClr val="tx1">
                    <a:tint val="75000"/>
                  </a:schemeClr>
                </a:solidFill>
              </a:defRPr>
            </a:lvl2pPr>
            <a:lvl3pPr marL="493253" indent="0">
              <a:buNone/>
              <a:defRPr sz="863">
                <a:solidFill>
                  <a:schemeClr val="tx1">
                    <a:tint val="75000"/>
                  </a:schemeClr>
                </a:solidFill>
              </a:defRPr>
            </a:lvl3pPr>
            <a:lvl4pPr marL="73987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98650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233131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4797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726383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97300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8990823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4"/>
            <a:ext cx="2506599" cy="2346956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>
              <a:defRPr sz="1726"/>
            </a:lvl1pPr>
            <a:lvl2pPr>
              <a:defRPr sz="1510"/>
            </a:lvl2pPr>
            <a:lvl3pPr>
              <a:defRPr sz="1295"/>
            </a:lvl3pPr>
            <a:lvl4pPr>
              <a:defRPr sz="1079"/>
            </a:lvl4pPr>
            <a:lvl5pPr>
              <a:defRPr sz="1079"/>
            </a:lvl5pPr>
            <a:lvl6pPr>
              <a:defRPr sz="1079"/>
            </a:lvl6pPr>
            <a:lvl7pPr>
              <a:defRPr sz="1079"/>
            </a:lvl7pPr>
            <a:lvl8pPr>
              <a:defRPr sz="1079"/>
            </a:lvl8pPr>
            <a:lvl9pPr>
              <a:defRPr sz="10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2"/>
            <a:ext cx="2506599" cy="5588002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128942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0"/>
            <a:ext cx="2506599" cy="2346960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 marL="0" indent="0">
              <a:buNone/>
              <a:defRPr sz="1726"/>
            </a:lvl1pPr>
            <a:lvl2pPr marL="246627" indent="0">
              <a:buNone/>
              <a:defRPr sz="1510"/>
            </a:lvl2pPr>
            <a:lvl3pPr marL="493253" indent="0">
              <a:buNone/>
              <a:defRPr sz="1295"/>
            </a:lvl3pPr>
            <a:lvl4pPr marL="739878" indent="0">
              <a:buNone/>
              <a:defRPr sz="1079"/>
            </a:lvl4pPr>
            <a:lvl5pPr marL="986505" indent="0">
              <a:buNone/>
              <a:defRPr sz="1079"/>
            </a:lvl5pPr>
            <a:lvl6pPr marL="1233131" indent="0">
              <a:buNone/>
              <a:defRPr sz="1079"/>
            </a:lvl6pPr>
            <a:lvl7pPr marL="1479757" indent="0">
              <a:buNone/>
              <a:defRPr sz="1079"/>
            </a:lvl7pPr>
            <a:lvl8pPr marL="1726383" indent="0">
              <a:buNone/>
              <a:defRPr sz="1079"/>
            </a:lvl8pPr>
            <a:lvl9pPr marL="1973009" indent="0">
              <a:buNone/>
              <a:defRPr sz="107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0"/>
            <a:ext cx="2506599" cy="5588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486475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4347130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3" y="528531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2" y="528535"/>
            <a:ext cx="4930616" cy="85240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75835075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1649311"/>
            <a:ext cx="5829300" cy="3501814"/>
          </a:xfrm>
        </p:spPr>
        <p:txBody>
          <a:bodyPr anchor="b">
            <a:normAutofit/>
          </a:bodyPr>
          <a:lstStyle>
            <a:lvl1pPr algn="ctr">
              <a:defRPr sz="323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90"/>
            <a:ext cx="5829300" cy="2428451"/>
          </a:xfrm>
        </p:spPr>
        <p:txBody>
          <a:bodyPr>
            <a:normAutofit/>
          </a:bodyPr>
          <a:lstStyle>
            <a:lvl1pPr marL="0" indent="0" algn="ctr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 algn="ctr">
              <a:buNone/>
              <a:defRPr sz="1510"/>
            </a:lvl2pPr>
            <a:lvl3pPr marL="493253" indent="0" algn="ctr">
              <a:buNone/>
              <a:defRPr sz="1295"/>
            </a:lvl3pPr>
            <a:lvl4pPr marL="739878" indent="0" algn="ctr">
              <a:buNone/>
              <a:defRPr sz="1079"/>
            </a:lvl4pPr>
            <a:lvl5pPr marL="986505" indent="0" algn="ctr">
              <a:buNone/>
              <a:defRPr sz="1079"/>
            </a:lvl5pPr>
            <a:lvl6pPr marL="1233131" indent="0" algn="ctr">
              <a:buNone/>
              <a:defRPr sz="1079"/>
            </a:lvl6pPr>
            <a:lvl7pPr marL="1479757" indent="0" algn="ctr">
              <a:buNone/>
              <a:defRPr sz="1079"/>
            </a:lvl7pPr>
            <a:lvl8pPr marL="1726383" indent="0" algn="ctr">
              <a:buNone/>
              <a:defRPr sz="1079"/>
            </a:lvl8pPr>
            <a:lvl9pPr marL="1973009" indent="0" algn="ctr">
              <a:buNone/>
              <a:defRPr sz="1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50372517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043521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7" y="2511554"/>
            <a:ext cx="6703695" cy="4181772"/>
          </a:xfrm>
        </p:spPr>
        <p:txBody>
          <a:bodyPr anchor="b">
            <a:normAutofit/>
          </a:bodyPr>
          <a:lstStyle>
            <a:lvl1pPr>
              <a:defRPr sz="3237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7" y="6677197"/>
            <a:ext cx="6703695" cy="2200274"/>
          </a:xfrm>
        </p:spPr>
        <p:txBody>
          <a:bodyPr anchor="t">
            <a:normAutofit/>
          </a:bodyPr>
          <a:lstStyle>
            <a:lvl1pPr marL="0" indent="0">
              <a:buNone/>
              <a:defRPr sz="1295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246627" indent="0">
              <a:buNone/>
              <a:defRPr sz="971">
                <a:solidFill>
                  <a:schemeClr val="tx1">
                    <a:tint val="75000"/>
                  </a:schemeClr>
                </a:solidFill>
              </a:defRPr>
            </a:lvl2pPr>
            <a:lvl3pPr marL="493253" indent="0">
              <a:buNone/>
              <a:defRPr sz="863">
                <a:solidFill>
                  <a:schemeClr val="tx1">
                    <a:tint val="75000"/>
                  </a:schemeClr>
                </a:solidFill>
              </a:defRPr>
            </a:lvl3pPr>
            <a:lvl4pPr marL="73987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98650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233131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479757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726383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97300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31262198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876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6068020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69" y="2466715"/>
            <a:ext cx="3287078" cy="1211026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8769" y="3677742"/>
            <a:ext cx="3287078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81" y="2466714"/>
            <a:ext cx="3303271" cy="1211024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81" y="3677742"/>
            <a:ext cx="3303271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3310476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202615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876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82244"/>
            <a:ext cx="3303270" cy="638196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771433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8172023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4"/>
            <a:ext cx="2506599" cy="2346956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>
              <a:defRPr sz="1726"/>
            </a:lvl1pPr>
            <a:lvl2pPr>
              <a:defRPr sz="1510"/>
            </a:lvl2pPr>
            <a:lvl3pPr>
              <a:defRPr sz="1295"/>
            </a:lvl3pPr>
            <a:lvl4pPr>
              <a:defRPr sz="1079"/>
            </a:lvl4pPr>
            <a:lvl5pPr>
              <a:defRPr sz="1079"/>
            </a:lvl5pPr>
            <a:lvl6pPr>
              <a:defRPr sz="1079"/>
            </a:lvl6pPr>
            <a:lvl7pPr>
              <a:defRPr sz="1079"/>
            </a:lvl7pPr>
            <a:lvl8pPr>
              <a:defRPr sz="1079"/>
            </a:lvl8pPr>
            <a:lvl9pPr>
              <a:defRPr sz="10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2"/>
            <a:ext cx="2506599" cy="5588002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13921771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0"/>
            <a:ext cx="2506599" cy="2346960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 marL="0" indent="0">
              <a:buNone/>
              <a:defRPr sz="1726"/>
            </a:lvl1pPr>
            <a:lvl2pPr marL="246627" indent="0">
              <a:buNone/>
              <a:defRPr sz="1510"/>
            </a:lvl2pPr>
            <a:lvl3pPr marL="493253" indent="0">
              <a:buNone/>
              <a:defRPr sz="1295"/>
            </a:lvl3pPr>
            <a:lvl4pPr marL="739878" indent="0">
              <a:buNone/>
              <a:defRPr sz="1079"/>
            </a:lvl4pPr>
            <a:lvl5pPr marL="986505" indent="0">
              <a:buNone/>
              <a:defRPr sz="1079"/>
            </a:lvl5pPr>
            <a:lvl6pPr marL="1233131" indent="0">
              <a:buNone/>
              <a:defRPr sz="1079"/>
            </a:lvl6pPr>
            <a:lvl7pPr marL="1479757" indent="0">
              <a:buNone/>
              <a:defRPr sz="1079"/>
            </a:lvl7pPr>
            <a:lvl8pPr marL="1726383" indent="0">
              <a:buNone/>
              <a:defRPr sz="1079"/>
            </a:lvl8pPr>
            <a:lvl9pPr marL="1973009" indent="0">
              <a:buNone/>
              <a:defRPr sz="107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0"/>
            <a:ext cx="2506599" cy="5588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19865289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9471094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3" y="528531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2" y="528535"/>
            <a:ext cx="4930616" cy="85240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5589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69" y="2466715"/>
            <a:ext cx="3287078" cy="1211026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8769" y="3677742"/>
            <a:ext cx="3287078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81" y="2466714"/>
            <a:ext cx="3303271" cy="1211024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295" b="1"/>
            </a:lvl1pPr>
            <a:lvl2pPr marL="246627" indent="0">
              <a:buNone/>
              <a:defRPr sz="1079" b="1"/>
            </a:lvl2pPr>
            <a:lvl3pPr marL="493253" indent="0">
              <a:buNone/>
              <a:defRPr sz="971" b="1"/>
            </a:lvl3pPr>
            <a:lvl4pPr marL="739878" indent="0">
              <a:buNone/>
              <a:defRPr sz="863" b="1"/>
            </a:lvl4pPr>
            <a:lvl5pPr marL="986505" indent="0">
              <a:buNone/>
              <a:defRPr sz="863" b="1"/>
            </a:lvl5pPr>
            <a:lvl6pPr marL="1233131" indent="0">
              <a:buNone/>
              <a:defRPr sz="863" b="1"/>
            </a:lvl6pPr>
            <a:lvl7pPr marL="1479757" indent="0">
              <a:buNone/>
              <a:defRPr sz="863" b="1"/>
            </a:lvl7pPr>
            <a:lvl8pPr marL="1726383" indent="0">
              <a:buNone/>
              <a:defRPr sz="863" b="1"/>
            </a:lvl8pPr>
            <a:lvl9pPr marL="1973009" indent="0">
              <a:buNone/>
              <a:defRPr sz="86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81" y="3677742"/>
            <a:ext cx="3303271" cy="53981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58519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325056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2799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4"/>
            <a:ext cx="2506599" cy="2346956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>
              <a:defRPr sz="1726"/>
            </a:lvl1pPr>
            <a:lvl2pPr>
              <a:defRPr sz="1510"/>
            </a:lvl2pPr>
            <a:lvl3pPr>
              <a:defRPr sz="1295"/>
            </a:lvl3pPr>
            <a:lvl4pPr>
              <a:defRPr sz="1079"/>
            </a:lvl4pPr>
            <a:lvl5pPr>
              <a:defRPr sz="1079"/>
            </a:lvl5pPr>
            <a:lvl6pPr>
              <a:defRPr sz="1079"/>
            </a:lvl6pPr>
            <a:lvl7pPr>
              <a:defRPr sz="1079"/>
            </a:lvl7pPr>
            <a:lvl8pPr>
              <a:defRPr sz="1079"/>
            </a:lvl8pPr>
            <a:lvl9pPr>
              <a:defRPr sz="10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2"/>
            <a:ext cx="2506599" cy="5588002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8342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297" y="670560"/>
            <a:ext cx="2506599" cy="2346960"/>
          </a:xfrm>
        </p:spPr>
        <p:txBody>
          <a:bodyPr anchor="b">
            <a:normAutofit/>
          </a:bodyPr>
          <a:lstStyle>
            <a:lvl1pPr>
              <a:defRPr sz="1726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303271" y="1452882"/>
            <a:ext cx="3934778" cy="7152640"/>
          </a:xfrm>
        </p:spPr>
        <p:txBody>
          <a:bodyPr/>
          <a:lstStyle>
            <a:lvl1pPr marL="0" indent="0">
              <a:buNone/>
              <a:defRPr sz="1726"/>
            </a:lvl1pPr>
            <a:lvl2pPr marL="246627" indent="0">
              <a:buNone/>
              <a:defRPr sz="1510"/>
            </a:lvl2pPr>
            <a:lvl3pPr marL="493253" indent="0">
              <a:buNone/>
              <a:defRPr sz="1295"/>
            </a:lvl3pPr>
            <a:lvl4pPr marL="739878" indent="0">
              <a:buNone/>
              <a:defRPr sz="1079"/>
            </a:lvl4pPr>
            <a:lvl5pPr marL="986505" indent="0">
              <a:buNone/>
              <a:defRPr sz="1079"/>
            </a:lvl5pPr>
            <a:lvl6pPr marL="1233131" indent="0">
              <a:buNone/>
              <a:defRPr sz="1079"/>
            </a:lvl6pPr>
            <a:lvl7pPr marL="1479757" indent="0">
              <a:buNone/>
              <a:defRPr sz="1079"/>
            </a:lvl7pPr>
            <a:lvl8pPr marL="1726383" indent="0">
              <a:buNone/>
              <a:defRPr sz="1079"/>
            </a:lvl8pPr>
            <a:lvl9pPr marL="1973009" indent="0">
              <a:buNone/>
              <a:defRPr sz="107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6297" y="3017520"/>
            <a:ext cx="2506599" cy="5588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863"/>
            </a:lvl1pPr>
            <a:lvl2pPr marL="246627" indent="0">
              <a:buNone/>
              <a:defRPr sz="647"/>
            </a:lvl2pPr>
            <a:lvl3pPr marL="493253" indent="0">
              <a:buNone/>
              <a:defRPr sz="540"/>
            </a:lvl3pPr>
            <a:lvl4pPr marL="739878" indent="0">
              <a:buNone/>
              <a:defRPr sz="486"/>
            </a:lvl4pPr>
            <a:lvl5pPr marL="986505" indent="0">
              <a:buNone/>
              <a:defRPr sz="486"/>
            </a:lvl5pPr>
            <a:lvl6pPr marL="1233131" indent="0">
              <a:buNone/>
              <a:defRPr sz="486"/>
            </a:lvl6pPr>
            <a:lvl7pPr marL="1479757" indent="0">
              <a:buNone/>
              <a:defRPr sz="486"/>
            </a:lvl7pPr>
            <a:lvl8pPr marL="1726383" indent="0">
              <a:buNone/>
              <a:defRPr sz="486"/>
            </a:lvl8pPr>
            <a:lvl9pPr marL="1973009" indent="0">
              <a:buNone/>
              <a:defRPr sz="48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7863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8771" y="536448"/>
            <a:ext cx="6703695" cy="19441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71" y="2682244"/>
            <a:ext cx="6703695" cy="63819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10" y="9322651"/>
            <a:ext cx="2623185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9367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93148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93253" rtl="0" eaLnBrk="1" latinLnBrk="0" hangingPunct="1">
        <a:lnSpc>
          <a:spcPct val="90000"/>
        </a:lnSpc>
        <a:spcBef>
          <a:spcPct val="0"/>
        </a:spcBef>
        <a:buNone/>
        <a:defRPr sz="23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3313" indent="-123313" algn="l" defTabSz="493253" rtl="0" eaLnBrk="1" latinLnBrk="0" hangingPunct="1">
        <a:lnSpc>
          <a:spcPct val="90000"/>
        </a:lnSpc>
        <a:spcBef>
          <a:spcPts val="540"/>
        </a:spcBef>
        <a:buFont typeface="Wingdings 2" pitchFamily="18" charset="2"/>
        <a:buChar char=""/>
        <a:defRPr sz="1510" kern="1200">
          <a:solidFill>
            <a:schemeClr val="tx1"/>
          </a:solidFill>
          <a:latin typeface="+mn-lt"/>
          <a:ea typeface="+mn-ea"/>
          <a:cs typeface="+mn-cs"/>
        </a:defRPr>
      </a:lvl1pPr>
      <a:lvl2pPr marL="369940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295" kern="1200">
          <a:solidFill>
            <a:schemeClr val="tx1"/>
          </a:solidFill>
          <a:latin typeface="+mn-lt"/>
          <a:ea typeface="+mn-ea"/>
          <a:cs typeface="+mn-cs"/>
        </a:defRPr>
      </a:lvl2pPr>
      <a:lvl3pPr marL="616566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079" kern="1200">
          <a:solidFill>
            <a:schemeClr val="tx1"/>
          </a:solidFill>
          <a:latin typeface="+mn-lt"/>
          <a:ea typeface="+mn-ea"/>
          <a:cs typeface="+mn-cs"/>
        </a:defRPr>
      </a:lvl3pPr>
      <a:lvl4pPr marL="863192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1109818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356444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603071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849697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2096323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1pPr>
      <a:lvl2pPr marL="24662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2pPr>
      <a:lvl3pPr marL="49325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3pPr>
      <a:lvl4pPr marL="739878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986505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233131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47975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72638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1973009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8771" y="536448"/>
            <a:ext cx="6703695" cy="19441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71" y="2682244"/>
            <a:ext cx="6703695" cy="63819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10" y="9322651"/>
            <a:ext cx="2623185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9367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0345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93253" rtl="0" eaLnBrk="1" latinLnBrk="0" hangingPunct="1">
        <a:lnSpc>
          <a:spcPct val="90000"/>
        </a:lnSpc>
        <a:spcBef>
          <a:spcPct val="0"/>
        </a:spcBef>
        <a:buNone/>
        <a:defRPr sz="23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3313" indent="-123313" algn="l" defTabSz="493253" rtl="0" eaLnBrk="1" latinLnBrk="0" hangingPunct="1">
        <a:lnSpc>
          <a:spcPct val="90000"/>
        </a:lnSpc>
        <a:spcBef>
          <a:spcPts val="540"/>
        </a:spcBef>
        <a:buFont typeface="Wingdings 2" pitchFamily="18" charset="2"/>
        <a:buChar char=""/>
        <a:defRPr sz="1510" kern="1200">
          <a:solidFill>
            <a:schemeClr val="tx1"/>
          </a:solidFill>
          <a:latin typeface="+mn-lt"/>
          <a:ea typeface="+mn-ea"/>
          <a:cs typeface="+mn-cs"/>
        </a:defRPr>
      </a:lvl1pPr>
      <a:lvl2pPr marL="369940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295" kern="1200">
          <a:solidFill>
            <a:schemeClr val="tx1"/>
          </a:solidFill>
          <a:latin typeface="+mn-lt"/>
          <a:ea typeface="+mn-ea"/>
          <a:cs typeface="+mn-cs"/>
        </a:defRPr>
      </a:lvl2pPr>
      <a:lvl3pPr marL="616566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079" kern="1200">
          <a:solidFill>
            <a:schemeClr val="tx1"/>
          </a:solidFill>
          <a:latin typeface="+mn-lt"/>
          <a:ea typeface="+mn-ea"/>
          <a:cs typeface="+mn-cs"/>
        </a:defRPr>
      </a:lvl3pPr>
      <a:lvl4pPr marL="863192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1109818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356444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603071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849697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2096323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1pPr>
      <a:lvl2pPr marL="24662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2pPr>
      <a:lvl3pPr marL="49325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3pPr>
      <a:lvl4pPr marL="739878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986505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233131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47975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72638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1973009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8771" y="536448"/>
            <a:ext cx="6703695" cy="19441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71" y="2682244"/>
            <a:ext cx="6703695" cy="63819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10" y="9322651"/>
            <a:ext cx="2623185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9367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3691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493253" rtl="0" eaLnBrk="1" latinLnBrk="0" hangingPunct="1">
        <a:lnSpc>
          <a:spcPct val="90000"/>
        </a:lnSpc>
        <a:spcBef>
          <a:spcPct val="0"/>
        </a:spcBef>
        <a:buNone/>
        <a:defRPr sz="23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3313" indent="-123313" algn="l" defTabSz="493253" rtl="0" eaLnBrk="1" latinLnBrk="0" hangingPunct="1">
        <a:lnSpc>
          <a:spcPct val="90000"/>
        </a:lnSpc>
        <a:spcBef>
          <a:spcPts val="540"/>
        </a:spcBef>
        <a:buFont typeface="Wingdings 2" pitchFamily="18" charset="2"/>
        <a:buChar char=""/>
        <a:defRPr sz="1510" kern="1200">
          <a:solidFill>
            <a:schemeClr val="tx1"/>
          </a:solidFill>
          <a:latin typeface="+mn-lt"/>
          <a:ea typeface="+mn-ea"/>
          <a:cs typeface="+mn-cs"/>
        </a:defRPr>
      </a:lvl1pPr>
      <a:lvl2pPr marL="369940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295" kern="1200">
          <a:solidFill>
            <a:schemeClr val="tx1"/>
          </a:solidFill>
          <a:latin typeface="+mn-lt"/>
          <a:ea typeface="+mn-ea"/>
          <a:cs typeface="+mn-cs"/>
        </a:defRPr>
      </a:lvl2pPr>
      <a:lvl3pPr marL="616566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079" kern="1200">
          <a:solidFill>
            <a:schemeClr val="tx1"/>
          </a:solidFill>
          <a:latin typeface="+mn-lt"/>
          <a:ea typeface="+mn-ea"/>
          <a:cs typeface="+mn-cs"/>
        </a:defRPr>
      </a:lvl3pPr>
      <a:lvl4pPr marL="863192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1109818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356444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603071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849697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2096323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1pPr>
      <a:lvl2pPr marL="24662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2pPr>
      <a:lvl3pPr marL="49325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3pPr>
      <a:lvl4pPr marL="739878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986505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233131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47975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72638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1973009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8771" y="536448"/>
            <a:ext cx="6703695" cy="19441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8771" y="2682244"/>
            <a:ext cx="6703695" cy="638196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77F2402-3AAB-4CD7-8496-626721FB8440}" type="datetimeFigureOut">
              <a:rPr lang="en-US" smtClean="0">
                <a:solidFill>
                  <a:prstClr val="black">
                    <a:lumMod val="65000"/>
                    <a:lumOff val="35000"/>
                  </a:prstClr>
                </a:solidFill>
              </a:rPr>
              <a:pPr/>
              <a:t>11/15/2020</a:t>
            </a:fld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10" y="9322651"/>
            <a:ext cx="2623185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93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lumMod val="65000"/>
                  <a:lumOff val="3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93673" y="9322651"/>
            <a:ext cx="1748790" cy="53551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4E226-59F0-4A16-97C8-EE0E69D05CC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3746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493253" rtl="0" eaLnBrk="1" latinLnBrk="0" hangingPunct="1">
        <a:lnSpc>
          <a:spcPct val="90000"/>
        </a:lnSpc>
        <a:spcBef>
          <a:spcPct val="0"/>
        </a:spcBef>
        <a:buNone/>
        <a:defRPr sz="23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3313" indent="-123313" algn="l" defTabSz="493253" rtl="0" eaLnBrk="1" latinLnBrk="0" hangingPunct="1">
        <a:lnSpc>
          <a:spcPct val="90000"/>
        </a:lnSpc>
        <a:spcBef>
          <a:spcPts val="540"/>
        </a:spcBef>
        <a:buFont typeface="Wingdings 2" pitchFamily="18" charset="2"/>
        <a:buChar char=""/>
        <a:defRPr sz="1510" kern="1200">
          <a:solidFill>
            <a:schemeClr val="tx1"/>
          </a:solidFill>
          <a:latin typeface="+mn-lt"/>
          <a:ea typeface="+mn-ea"/>
          <a:cs typeface="+mn-cs"/>
        </a:defRPr>
      </a:lvl1pPr>
      <a:lvl2pPr marL="369940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295" kern="1200">
          <a:solidFill>
            <a:schemeClr val="tx1"/>
          </a:solidFill>
          <a:latin typeface="+mn-lt"/>
          <a:ea typeface="+mn-ea"/>
          <a:cs typeface="+mn-cs"/>
        </a:defRPr>
      </a:lvl2pPr>
      <a:lvl3pPr marL="616566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1079" kern="1200">
          <a:solidFill>
            <a:schemeClr val="tx1"/>
          </a:solidFill>
          <a:latin typeface="+mn-lt"/>
          <a:ea typeface="+mn-ea"/>
          <a:cs typeface="+mn-cs"/>
        </a:defRPr>
      </a:lvl3pPr>
      <a:lvl4pPr marL="863192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1109818" indent="-123313" algn="l" defTabSz="493253" rtl="0" eaLnBrk="1" latinLnBrk="0" hangingPunct="1">
        <a:lnSpc>
          <a:spcPct val="90000"/>
        </a:lnSpc>
        <a:spcBef>
          <a:spcPts val="27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356444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603071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849697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2096323" indent="-123313" algn="l" defTabSz="493253" rtl="0" eaLnBrk="1" latinLnBrk="0" hangingPunct="1">
        <a:spcBef>
          <a:spcPct val="20000"/>
        </a:spcBef>
        <a:buFont typeface="Wingdings 2" pitchFamily="18" charset="2"/>
        <a:buChar char=""/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1pPr>
      <a:lvl2pPr marL="24662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2pPr>
      <a:lvl3pPr marL="49325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3pPr>
      <a:lvl4pPr marL="739878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4pPr>
      <a:lvl5pPr marL="986505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5pPr>
      <a:lvl6pPr marL="1233131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6pPr>
      <a:lvl7pPr marL="1479757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7pPr>
      <a:lvl8pPr marL="1726383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8pPr>
      <a:lvl9pPr marL="1973009" algn="l" defTabSz="493253" rtl="0" eaLnBrk="1" latinLnBrk="0" hangingPunct="1">
        <a:defRPr sz="9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9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29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package" Target="../embeddings/Microsoft_Excel_Worksheet.xlsx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4378" y="733500"/>
            <a:ext cx="4742368" cy="146479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251483" y="342367"/>
            <a:ext cx="3983783" cy="3911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1. List of primers used in genotyping PCR.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74877B7-FE5E-4002-AC6D-560F720A186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02"/>
          <a:stretch/>
        </p:blipFill>
        <p:spPr>
          <a:xfrm>
            <a:off x="1616337" y="3049943"/>
            <a:ext cx="3838768" cy="35573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0EA675-1987-4C56-B0A2-8DB50680FF8A}"/>
              </a:ext>
            </a:extLst>
          </p:cNvPr>
          <p:cNvSpPr txBox="1"/>
          <p:nvPr/>
        </p:nvSpPr>
        <p:spPr>
          <a:xfrm>
            <a:off x="1412683" y="2977171"/>
            <a:ext cx="298728" cy="241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971" b="1" dirty="0"/>
              <a:t>A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DD99E7C-92D9-4269-B6F3-F4D36296498E}"/>
              </a:ext>
            </a:extLst>
          </p:cNvPr>
          <p:cNvSpPr/>
          <p:nvPr/>
        </p:nvSpPr>
        <p:spPr>
          <a:xfrm>
            <a:off x="1394378" y="2515801"/>
            <a:ext cx="4060727" cy="3911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2. List of antibodies used in flow cytometry.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FA86B53-A539-4F66-AAF7-3730799D8F9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925"/>
          <a:stretch/>
        </p:blipFill>
        <p:spPr>
          <a:xfrm>
            <a:off x="1678018" y="6897139"/>
            <a:ext cx="3130715" cy="253668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5BAB55B-8149-4BB5-A25A-F1FC58F66D1A}"/>
              </a:ext>
            </a:extLst>
          </p:cNvPr>
          <p:cNvSpPr txBox="1"/>
          <p:nvPr/>
        </p:nvSpPr>
        <p:spPr>
          <a:xfrm>
            <a:off x="1528654" y="6655406"/>
            <a:ext cx="298728" cy="241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971" b="1" dirty="0"/>
              <a:t>B. </a:t>
            </a:r>
          </a:p>
        </p:txBody>
      </p:sp>
    </p:spTree>
    <p:extLst>
      <p:ext uri="{BB962C8B-B14F-4D97-AF65-F5344CB8AC3E}">
        <p14:creationId xmlns:p14="http://schemas.microsoft.com/office/powerpoint/2010/main" val="591584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66777" y="904193"/>
            <a:ext cx="4771979" cy="146879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165422" y="177715"/>
            <a:ext cx="4873334" cy="6899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3. Human pericardial adipose tissue donor information. </a:t>
            </a:r>
            <a:r>
              <a:rPr lang="en-US" sz="97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MA SVG: left internal mammary artery, saphenous vein graft. MVR: mitral valve repair/replacement. AVR: aortic valve repair/replacement. BMI, body mass index. DM, type 2 diabetes mellitus.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1BA246F-F28D-4968-A3B4-501E130663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6777" y="2846747"/>
            <a:ext cx="2619423" cy="2339192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64D4774-31F5-4BF8-8800-FCD5B44D6A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2495598"/>
              </p:ext>
            </p:extLst>
          </p:nvPr>
        </p:nvGraphicFramePr>
        <p:xfrm>
          <a:off x="1266777" y="5651611"/>
          <a:ext cx="2471614" cy="1518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Worksheet" r:id="rId5" imgW="2790967" imgH="1714334" progId="Excel.Sheet.12">
                  <p:embed/>
                </p:oleObj>
              </mc:Choice>
              <mc:Fallback>
                <p:oleObj name="Worksheet" r:id="rId5" imgW="2790967" imgH="1714334" progId="Excel.Sheet.12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64D4774-31F5-4BF8-8800-FCD5B44D6A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66777" y="5651611"/>
                        <a:ext cx="2471614" cy="1518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6A1C36F9-2679-43F5-8FE3-104989867215}"/>
              </a:ext>
            </a:extLst>
          </p:cNvPr>
          <p:cNvSpPr/>
          <p:nvPr/>
        </p:nvSpPr>
        <p:spPr>
          <a:xfrm>
            <a:off x="1165422" y="5260478"/>
            <a:ext cx="3900427" cy="39113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5. List of antibodies used in Western blot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51FC7E8-A4A8-42F8-9C24-E33CE04FA799}"/>
              </a:ext>
            </a:extLst>
          </p:cNvPr>
          <p:cNvSpPr/>
          <p:nvPr/>
        </p:nvSpPr>
        <p:spPr>
          <a:xfrm>
            <a:off x="1165422" y="2419959"/>
            <a:ext cx="3626314" cy="3483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4. Human blood donor information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9B27EE5-94DA-4A53-8AAF-56E7D7DC59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87558" y="7956482"/>
            <a:ext cx="3504178" cy="1483575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2700144-AF2C-4F07-BE1D-583404F0C517}"/>
              </a:ext>
            </a:extLst>
          </p:cNvPr>
          <p:cNvSpPr/>
          <p:nvPr/>
        </p:nvSpPr>
        <p:spPr>
          <a:xfrm>
            <a:off x="1215651" y="7561141"/>
            <a:ext cx="4963218" cy="3483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200000"/>
              </a:lnSpc>
              <a:spcAft>
                <a:spcPts val="432"/>
              </a:spcAft>
            </a:pPr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971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6. Nutrient Components in Normal Chow and High-fat Diet</a:t>
            </a:r>
            <a:endParaRPr lang="en-US" sz="97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5750604"/>
      </p:ext>
    </p:extLst>
  </p:cSld>
  <p:clrMapOvr>
    <a:masterClrMapping/>
  </p:clrMapOvr>
</p:sld>
</file>

<file path=ppt/theme/theme1.xml><?xml version="1.0" encoding="utf-8"?>
<a:theme xmlns:a="http://schemas.openxmlformats.org/drawingml/2006/main" name="1_HDOfficeLightV0">
  <a:themeElements>
    <a:clrScheme name="Yellow">
      <a:dk1>
        <a:sysClr val="windowText" lastClr="000000"/>
      </a:dk1>
      <a:lt1>
        <a:sysClr val="window" lastClr="FFFFFF"/>
      </a:lt1>
      <a:dk2>
        <a:srgbClr val="39302A"/>
      </a:dk2>
      <a:lt2>
        <a:srgbClr val="E5DEDB"/>
      </a:lt2>
      <a:accent1>
        <a:srgbClr val="FFCA08"/>
      </a:accent1>
      <a:accent2>
        <a:srgbClr val="F8931D"/>
      </a:accent2>
      <a:accent3>
        <a:srgbClr val="CE8D3E"/>
      </a:accent3>
      <a:accent4>
        <a:srgbClr val="EC7016"/>
      </a:accent4>
      <a:accent5>
        <a:srgbClr val="E64823"/>
      </a:accent5>
      <a:accent6>
        <a:srgbClr val="9C6A6A"/>
      </a:accent6>
      <a:hlink>
        <a:srgbClr val="2998E3"/>
      </a:hlink>
      <a:folHlink>
        <a:srgbClr val="7F723D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2_HDOfficeLightV0">
  <a:themeElements>
    <a:clrScheme name="Yellow">
      <a:dk1>
        <a:sysClr val="windowText" lastClr="000000"/>
      </a:dk1>
      <a:lt1>
        <a:sysClr val="window" lastClr="FFFFFF"/>
      </a:lt1>
      <a:dk2>
        <a:srgbClr val="39302A"/>
      </a:dk2>
      <a:lt2>
        <a:srgbClr val="E5DEDB"/>
      </a:lt2>
      <a:accent1>
        <a:srgbClr val="FFCA08"/>
      </a:accent1>
      <a:accent2>
        <a:srgbClr val="F8931D"/>
      </a:accent2>
      <a:accent3>
        <a:srgbClr val="CE8D3E"/>
      </a:accent3>
      <a:accent4>
        <a:srgbClr val="EC7016"/>
      </a:accent4>
      <a:accent5>
        <a:srgbClr val="E64823"/>
      </a:accent5>
      <a:accent6>
        <a:srgbClr val="9C6A6A"/>
      </a:accent6>
      <a:hlink>
        <a:srgbClr val="2998E3"/>
      </a:hlink>
      <a:folHlink>
        <a:srgbClr val="7F723D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3_HDOfficeLightV0">
  <a:themeElements>
    <a:clrScheme name="Yellow">
      <a:dk1>
        <a:sysClr val="windowText" lastClr="000000"/>
      </a:dk1>
      <a:lt1>
        <a:sysClr val="window" lastClr="FFFFFF"/>
      </a:lt1>
      <a:dk2>
        <a:srgbClr val="39302A"/>
      </a:dk2>
      <a:lt2>
        <a:srgbClr val="E5DEDB"/>
      </a:lt2>
      <a:accent1>
        <a:srgbClr val="FFCA08"/>
      </a:accent1>
      <a:accent2>
        <a:srgbClr val="F8931D"/>
      </a:accent2>
      <a:accent3>
        <a:srgbClr val="CE8D3E"/>
      </a:accent3>
      <a:accent4>
        <a:srgbClr val="EC7016"/>
      </a:accent4>
      <a:accent5>
        <a:srgbClr val="E64823"/>
      </a:accent5>
      <a:accent6>
        <a:srgbClr val="9C6A6A"/>
      </a:accent6>
      <a:hlink>
        <a:srgbClr val="2998E3"/>
      </a:hlink>
      <a:folHlink>
        <a:srgbClr val="7F723D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4_HDOfficeLightV0">
  <a:themeElements>
    <a:clrScheme name="Yellow">
      <a:dk1>
        <a:sysClr val="windowText" lastClr="000000"/>
      </a:dk1>
      <a:lt1>
        <a:sysClr val="window" lastClr="FFFFFF"/>
      </a:lt1>
      <a:dk2>
        <a:srgbClr val="39302A"/>
      </a:dk2>
      <a:lt2>
        <a:srgbClr val="E5DEDB"/>
      </a:lt2>
      <a:accent1>
        <a:srgbClr val="FFCA08"/>
      </a:accent1>
      <a:accent2>
        <a:srgbClr val="F8931D"/>
      </a:accent2>
      <a:accent3>
        <a:srgbClr val="CE8D3E"/>
      </a:accent3>
      <a:accent4>
        <a:srgbClr val="EC7016"/>
      </a:accent4>
      <a:accent5>
        <a:srgbClr val="E64823"/>
      </a:accent5>
      <a:accent6>
        <a:srgbClr val="9C6A6A"/>
      </a:accent6>
      <a:hlink>
        <a:srgbClr val="2998E3"/>
      </a:hlink>
      <a:folHlink>
        <a:srgbClr val="7F723D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48</TotalTime>
  <Words>112</Words>
  <Application>Microsoft Office PowerPoint</Application>
  <PresentationFormat>Custom</PresentationFormat>
  <Paragraphs>9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4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1" baseType="lpstr">
      <vt:lpstr>Arial</vt:lpstr>
      <vt:lpstr>Calibri</vt:lpstr>
      <vt:lpstr>Calibri Light</vt:lpstr>
      <vt:lpstr>Wingdings 2</vt:lpstr>
      <vt:lpstr>1_HDOfficeLightV0</vt:lpstr>
      <vt:lpstr>2_HDOfficeLightV0</vt:lpstr>
      <vt:lpstr>3_HDOfficeLightV0</vt:lpstr>
      <vt:lpstr>4_HDOfficeLightV0</vt:lpstr>
      <vt:lpstr>Workshee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Candice Jo</dc:creator>
  <cp:lastModifiedBy>Yu Sun</cp:lastModifiedBy>
  <cp:revision>255</cp:revision>
  <cp:lastPrinted>2020-10-15T18:58:55Z</cp:lastPrinted>
  <dcterms:created xsi:type="dcterms:W3CDTF">2020-04-03T01:21:11Z</dcterms:created>
  <dcterms:modified xsi:type="dcterms:W3CDTF">2020-11-16T02:24:22Z</dcterms:modified>
</cp:coreProperties>
</file>